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  <a:srgbClr val="008000"/>
    <a:srgbClr val="009999"/>
    <a:srgbClr val="FF99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72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02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69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71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6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62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307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3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84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67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99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67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597727" y="5313040"/>
            <a:ext cx="564886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900" b="1">
                <a:latin typeface="Century Schoolbook" panose="02040604050505020304" pitchFamily="18" charset="0"/>
                <a:ea typeface="Times New Roman" panose="02020603050405020304" pitchFamily="18" charset="0"/>
              </a:rPr>
              <a:t>Fig. </a:t>
            </a:r>
            <a:r>
              <a:rPr lang="en-GB" sz="900" b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S6.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Effect of BSA on the activity of </a:t>
            </a:r>
            <a:r>
              <a:rPr lang="en-GB" sz="900" i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Pichia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-produced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TG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with soluble and insoluble donor-substrates. </a:t>
            </a:r>
          </a:p>
          <a:p>
            <a:pPr>
              <a:spcAft>
                <a:spcPts val="600"/>
              </a:spcAft>
            </a:pP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The reaction mixtures were as in Fig. 4b, with three donor-substrates [alkali-pretreated filter-paper (insoluble), xyloglucan and MLG (both water-soluble)]. The acceptor-substrate was [</a:t>
            </a:r>
            <a:r>
              <a:rPr lang="en-GB" sz="900" baseline="300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. The BSA, when present, was at a final concentration of 1.1 mg/ml. Linear regressions are fitted. Reaction rates (± SE) are thereby estimated at: </a:t>
            </a:r>
          </a:p>
          <a:p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MLG 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+ BSA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	8.51 ± 0.019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MLG –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SA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	7.20 ± 0.019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xyloglucan 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SA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	1.16 ± 0.009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x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yloglucan –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SA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	1.14 ± 0.01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cellulose +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SA	4.90 ± 0.019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c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ellulose –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SA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	0.207 ± 0.014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Bq kBq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 h</a:t>
            </a:r>
            <a:r>
              <a:rPr lang="en-GB" sz="8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–1</a:t>
            </a:r>
            <a:endParaRPr lang="en-GB" sz="8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73216" y="20047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6</a:t>
            </a:r>
          </a:p>
        </p:txBody>
      </p:sp>
      <p:pic>
        <p:nvPicPr>
          <p:cNvPr id="3075" name="Picture 3" descr="H:\Fig. S6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14" t="1502" r="14811" b="40488"/>
          <a:stretch/>
        </p:blipFill>
        <p:spPr bwMode="auto">
          <a:xfrm>
            <a:off x="1682480" y="835256"/>
            <a:ext cx="3672408" cy="4161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4293096" y="3068520"/>
            <a:ext cx="40075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009999"/>
                </a:solidFill>
                <a:latin typeface="Arial Narrow" pitchFamily="34" charset="0"/>
                <a:cs typeface="Arial" pitchFamily="34" charset="0"/>
              </a:rPr>
              <a:t>cellulose +</a:t>
            </a:r>
            <a:endParaRPr lang="en-GB" sz="800">
              <a:solidFill>
                <a:srgbClr val="009999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293096" y="4376936"/>
            <a:ext cx="39754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009999"/>
                </a:solidFill>
                <a:latin typeface="Arial Narrow" pitchFamily="34" charset="0"/>
                <a:cs typeface="Arial" pitchFamily="34" charset="0"/>
              </a:rPr>
              <a:t>cellulose –</a:t>
            </a:r>
            <a:endParaRPr lang="en-GB" sz="800">
              <a:solidFill>
                <a:srgbClr val="009999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52452" y="3996473"/>
            <a:ext cx="4696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008000"/>
                </a:solidFill>
                <a:latin typeface="Arial Narrow" pitchFamily="34" charset="0"/>
                <a:cs typeface="Arial" pitchFamily="34" charset="0"/>
              </a:rPr>
              <a:t>xyloglucan +</a:t>
            </a:r>
            <a:endParaRPr lang="en-GB" sz="800">
              <a:solidFill>
                <a:srgbClr val="008000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52452" y="4209429"/>
            <a:ext cx="4664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008000"/>
                </a:solidFill>
                <a:latin typeface="Arial Narrow" pitchFamily="34" charset="0"/>
                <a:cs typeface="Arial" pitchFamily="34" charset="0"/>
              </a:rPr>
              <a:t>xyloglucan –</a:t>
            </a:r>
            <a:endParaRPr lang="en-GB" sz="800">
              <a:solidFill>
                <a:srgbClr val="008000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365104" y="1136576"/>
            <a:ext cx="2564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rPr>
              <a:t>MLG +</a:t>
            </a:r>
            <a:endParaRPr lang="en-GB" sz="800">
              <a:solidFill>
                <a:srgbClr val="FF0000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365104" y="1997604"/>
            <a:ext cx="253274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smtClean="0">
                <a:solidFill>
                  <a:srgbClr val="FF0000"/>
                </a:solidFill>
                <a:latin typeface="Arial Narrow" pitchFamily="34" charset="0"/>
                <a:cs typeface="Arial" pitchFamily="34" charset="0"/>
              </a:rPr>
              <a:t>MLG –</a:t>
            </a:r>
            <a:endParaRPr lang="en-GB" sz="800">
              <a:solidFill>
                <a:srgbClr val="FF0000"/>
              </a:solidFill>
              <a:latin typeface="Arial Narrow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348880" y="1136576"/>
            <a:ext cx="1694695" cy="52322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700" b="1" smtClean="0">
                <a:latin typeface="Arial" panose="020B0604020202020204" pitchFamily="34" charset="0"/>
                <a:cs typeface="Arial" panose="020B0604020202020204" pitchFamily="34" charset="0"/>
              </a:rPr>
              <a:t>Donors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: MLG, xyloglucan or cellulose</a:t>
            </a:r>
          </a:p>
          <a:p>
            <a:r>
              <a:rPr lang="en-GB" sz="700" b="1" smtClean="0">
                <a:latin typeface="Arial" panose="020B0604020202020204" pitchFamily="34" charset="0"/>
                <a:cs typeface="Arial" panose="020B0604020202020204" pitchFamily="34" charset="0"/>
              </a:rPr>
              <a:t>Acceptor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: XXXGol</a:t>
            </a:r>
          </a:p>
          <a:p>
            <a:r>
              <a:rPr lang="en-GB" sz="700" b="1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 = with BSA</a:t>
            </a:r>
          </a:p>
          <a:p>
            <a:r>
              <a:rPr lang="en-GB" sz="700" b="1" smtClean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 = without BSA</a:t>
            </a:r>
            <a:endParaRPr lang="en-GB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9996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118</Words>
  <Application>Microsoft Office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Steve Fry</cp:lastModifiedBy>
  <cp:revision>95</cp:revision>
  <cp:lastPrinted>2015-03-02T19:14:39Z</cp:lastPrinted>
  <dcterms:created xsi:type="dcterms:W3CDTF">2014-10-24T13:36:09Z</dcterms:created>
  <dcterms:modified xsi:type="dcterms:W3CDTF">2015-07-12T20:28:08Z</dcterms:modified>
</cp:coreProperties>
</file>